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>
        <p:scale>
          <a:sx n="100" d="100"/>
          <a:sy n="100" d="100"/>
        </p:scale>
        <p:origin x="1483" y="-15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2A99B8-C7DF-4E7A-8D7D-2D7AFF60817D}" type="datetimeFigureOut">
              <a:rPr kumimoji="1" lang="ja-JP" altLang="en-US" smtClean="0"/>
              <a:t>2025/10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B21BB3-F66A-4512-AD87-76ED594DBA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83035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52E06-8807-4DD2-8490-78D05A144C52}" type="datetime1">
              <a:rPr kumimoji="1" lang="ja-JP" altLang="en-US" smtClean="0"/>
              <a:t>2025/10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kumimoji="1" lang="en-US" altLang="ja-JP"/>
              <a:t>P</a:t>
            </a:r>
            <a:fld id="{B7C7EF6F-77F1-45E6-BA2F-4377D5A7BAB9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101290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A6152-6F2F-40A0-B50D-09FDFD452AE7}" type="datetime1">
              <a:rPr kumimoji="1" lang="ja-JP" altLang="en-US" smtClean="0"/>
              <a:t>2025/10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7EF6F-77F1-45E6-BA2F-4377D5A7BA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2792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85904-730D-415C-99F7-63E6F0E28DB1}" type="datetime1">
              <a:rPr kumimoji="1" lang="ja-JP" altLang="en-US" smtClean="0"/>
              <a:t>2025/10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7EF6F-77F1-45E6-BA2F-4377D5A7BA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10791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CE75F-30C5-412D-9B68-858E5E8E6101}" type="datetime1">
              <a:rPr kumimoji="1" lang="ja-JP" altLang="en-US" smtClean="0"/>
              <a:t>2025/10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7EF6F-77F1-45E6-BA2F-4377D5A7BA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43320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161F3-DB4A-4509-9743-3806BDBBB740}" type="datetime1">
              <a:rPr kumimoji="1" lang="ja-JP" altLang="en-US" smtClean="0"/>
              <a:t>2025/10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7EF6F-77F1-45E6-BA2F-4377D5A7BA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3624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0DDDC-244A-4159-BB9C-202B93E83552}" type="datetime1">
              <a:rPr kumimoji="1" lang="ja-JP" altLang="en-US" smtClean="0"/>
              <a:t>2025/10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7EF6F-77F1-45E6-BA2F-4377D5A7BA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6728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1F1F-282E-4BA5-A694-449733DCB22F}" type="datetime1">
              <a:rPr kumimoji="1" lang="ja-JP" altLang="en-US" smtClean="0"/>
              <a:t>2025/10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7EF6F-77F1-45E6-BA2F-4377D5A7BA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15834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1E926-D4BF-43D6-9F68-AEDAD32C071E}" type="datetime1">
              <a:rPr kumimoji="1" lang="ja-JP" altLang="en-US" smtClean="0"/>
              <a:t>2025/10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7EF6F-77F1-45E6-BA2F-4377D5A7BA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0657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C8133-5416-4E97-A950-2F4A995EA079}" type="datetime1">
              <a:rPr kumimoji="1" lang="ja-JP" altLang="en-US" smtClean="0"/>
              <a:t>2025/10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7EF6F-77F1-45E6-BA2F-4377D5A7BA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53800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10822-7A63-43FB-9887-851D9C9085C0}" type="datetime1">
              <a:rPr kumimoji="1" lang="ja-JP" altLang="en-US" smtClean="0"/>
              <a:t>2025/10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7EF6F-77F1-45E6-BA2F-4377D5A7BA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1212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3F562-63F2-44F9-A46E-D6148F862C90}" type="datetime1">
              <a:rPr kumimoji="1" lang="ja-JP" altLang="en-US" smtClean="0"/>
              <a:t>2025/10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7EF6F-77F1-45E6-BA2F-4377D5A7BA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57689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3A3D5E-4A8C-4A21-9A93-AB5ED3BCACD3}" type="datetime1">
              <a:rPr kumimoji="1" lang="ja-JP" altLang="en-US" smtClean="0"/>
              <a:t>2025/10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C7EF6F-77F1-45E6-BA2F-4377D5A7BA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5973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番号プレースホルダー 1">
            <a:extLst>
              <a:ext uri="{FF2B5EF4-FFF2-40B4-BE49-F238E27FC236}">
                <a16:creationId xmlns:a16="http://schemas.microsoft.com/office/drawing/2014/main" id="{91869F91-C931-6142-7E4D-2EB9FAE6C9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7EF6F-77F1-45E6-BA2F-4377D5A7BAB9}" type="slidenum">
              <a:rPr kumimoji="1" lang="ja-JP" altLang="en-US" smtClean="0"/>
              <a:t>1</a:t>
            </a:fld>
            <a:endParaRPr kumimoji="1"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FA0699B-49A3-A678-9107-F1BDBC31F8C3}"/>
              </a:ext>
            </a:extLst>
          </p:cNvPr>
          <p:cNvSpPr txBox="1"/>
          <p:nvPr/>
        </p:nvSpPr>
        <p:spPr>
          <a:xfrm>
            <a:off x="659835" y="6029622"/>
            <a:ext cx="5726678" cy="1600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/>
              <a:t>Supplementary Figure S1. Heatmap of A45 vs PEG treatments.</a:t>
            </a:r>
          </a:p>
          <a:p>
            <a:r>
              <a:rPr lang="en-US" altLang="ja-JP" sz="1400" dirty="0"/>
              <a:t>Heatmap showing the direct comparison between A45- and PEG-treated groups. Four metabolites (C_0120, C_0047, C_0072, A_0060) that met the significance threshold (FDR &lt; 0.05) displayed opposite expression patterns, resulting in a clear separation of A45 and PEG groups. </a:t>
            </a:r>
            <a:r>
              <a:rPr lang="en-US" altLang="ja-JP" sz="1400"/>
              <a:t>These results further support that metabolic alterations induced by A45 are distinct from those associated with PEG treatment.</a:t>
            </a:r>
            <a:endParaRPr lang="ja-JP" altLang="en-US" sz="1400" dirty="0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88EF1E5E-48C0-1ABE-6C56-A6A861BE5AC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9835" y="1949274"/>
            <a:ext cx="5090160" cy="38176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19407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48</TotalTime>
  <Words>87</Words>
  <Application>Microsoft Office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弘人 和泉</dc:creator>
  <cp:lastModifiedBy>和泉弘人</cp:lastModifiedBy>
  <cp:revision>20</cp:revision>
  <dcterms:created xsi:type="dcterms:W3CDTF">2021-02-14T08:25:28Z</dcterms:created>
  <dcterms:modified xsi:type="dcterms:W3CDTF">2025-10-03T03:43:03Z</dcterms:modified>
</cp:coreProperties>
</file>